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80" r:id="rId3"/>
    <p:sldId id="264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4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B2D11-E0A3-49C7-AC25-CDB25577D6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13DF96-693F-42EE-8CAA-963B6D5D7C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D7CF4B-6881-4038-A759-14E37D8F1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A71295-8C7A-4C61-92AC-EED8E3AE0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2E57FD-90FF-42A6-B11C-5273BD545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215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83E3A4-3E9E-4897-9FCC-43C63B9F19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86E420-AD15-42F0-99A8-370A930FAC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742FD3-1560-406C-9284-5271C338B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D3A83B-2CF9-4B9B-832C-B2762AF95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DA0F3D-B740-4E81-B482-807B81F2D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647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C6EFEC-5E16-4703-8862-5E2A95EE3B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3BF877-B550-4E26-A872-1889A61755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6614E8-1DD5-490D-AEEA-65EA60165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CB5E69-C1FF-4B43-B36E-EAB4F7114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A8270B-2627-4077-A914-3E864D135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126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D7BA8-B153-4625-84CC-A034D72CBE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D30DAB-6137-49BA-AAB6-49CC666077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889C0-90D7-4077-9658-8C684CD64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F056D-41AC-45FF-9822-493E1A951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51743-FA66-4A86-A8EE-3FF887A32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022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705F4-28DC-4A1A-BD72-DD870AA44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904E9D-E832-4D4C-858A-3A21611546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849535-16B9-431F-8550-C4D2EAFB4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22204-7509-47CB-939F-4ACED7780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A8E1F4-C561-420F-B82A-6AE100D47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697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2C232-72B4-4C5B-8DBA-17F8AB2B8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EAC8BA-A192-4B79-A819-1867CAA596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0954A4-F89E-41D2-8D1C-B153C4A269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CBA976-FB59-4506-A680-9127663DE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A983A8-A3F4-43DD-8FF6-642D8F676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C0FFCC-7F6A-45E6-8057-F607477C1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549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CD3332-6623-43F9-9819-61A2234891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14A6E4-5AB1-4191-9547-9BA2F3618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7754E4-D5EE-4DBA-A98F-FBF891601E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E5396C-92D5-42B7-B110-B8C1E828B3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1B7659-227C-412A-8193-FDEDEA9326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FF9559-61FB-4FC4-96E2-2C716D392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393454E-F73F-450A-B7EA-7BB1BCB8C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D24EF59-F281-4A73-B460-62C96F7C1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667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BD02C-B6E9-4A61-A254-6FAB995FA2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5CC9ED-8D0A-4FBD-8861-9A50DCEAB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7D7A9A-3002-49E4-B2A3-3A7231E81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C90CFD-77B9-4C6D-A535-F5822C8C2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740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D0590F-F752-4361-A164-81AF40B0F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2B7C0D-4323-4BA2-A54C-49D6A1159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1AAC99-0E7B-4F19-BD53-839EE5648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38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8A90C-034B-45CA-94E3-2EE27D25E3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68FA4E-420C-4360-B194-CC6C2F23CD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33FE19-FC7A-45DF-B8C2-DD2772803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7D2C4F-781E-4131-806F-614957834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DED939-204D-42AD-A2D0-5C7E64569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2FF506-7FDC-4092-909B-7120E5BA9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706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EC5BD-69D9-4627-B2E8-D414A4D0D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DBFBFE-98C3-4118-B7AC-3C2D65F64A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9B5A97-3412-424B-85DE-CCCAC58927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390973-73C6-48C1-8B94-3B03A0C5E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CD624E-BB06-42CA-B66A-758EE251B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0AF320-DB43-4FE7-BC47-A684E4CFC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372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73FD78-C11C-48CD-B83A-67A1D7240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75A368-228D-4A7A-96F5-72235F6F59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48DF47-065C-4559-A356-1C1623DAE3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312B9-EE08-4CF7-B942-3992F519072D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C2AA6-5027-4698-9391-8B497824A4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573CF6-5F92-4245-A15E-C2678489C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589FF-DEBE-4CE3-8A91-DAD7103F28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65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7039D32-6E49-E640-AF67-41B451CD73E0}"/>
              </a:ext>
            </a:extLst>
          </p:cNvPr>
          <p:cNvSpPr txBox="1"/>
          <p:nvPr/>
        </p:nvSpPr>
        <p:spPr>
          <a:xfrm>
            <a:off x="1629605" y="914253"/>
            <a:ext cx="51476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. Primer sequences for QRT-PCR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D25A0EA-B475-FB4A-BC60-CC56634C3FCC}"/>
              </a:ext>
            </a:extLst>
          </p:cNvPr>
          <p:cNvCxnSpPr>
            <a:cxnSpLocks/>
          </p:cNvCxnSpPr>
          <p:nvPr/>
        </p:nvCxnSpPr>
        <p:spPr>
          <a:xfrm>
            <a:off x="1680519" y="1269414"/>
            <a:ext cx="86963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12019E2-2E10-A141-8686-928A7C9138F6}"/>
              </a:ext>
            </a:extLst>
          </p:cNvPr>
          <p:cNvSpPr txBox="1"/>
          <p:nvPr/>
        </p:nvSpPr>
        <p:spPr>
          <a:xfrm>
            <a:off x="5877560" y="1332446"/>
            <a:ext cx="15376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imer sequence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6710B358-9AE0-BB47-B885-334EC888CD8A}"/>
              </a:ext>
            </a:extLst>
          </p:cNvPr>
          <p:cNvCxnSpPr>
            <a:cxnSpLocks/>
          </p:cNvCxnSpPr>
          <p:nvPr/>
        </p:nvCxnSpPr>
        <p:spPr>
          <a:xfrm>
            <a:off x="3880022" y="1685063"/>
            <a:ext cx="64968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DC0DDF9-416F-6645-AEEA-79A3BE8F18F1}"/>
              </a:ext>
            </a:extLst>
          </p:cNvPr>
          <p:cNvSpPr txBox="1"/>
          <p:nvPr/>
        </p:nvSpPr>
        <p:spPr>
          <a:xfrm>
            <a:off x="1904014" y="1901087"/>
            <a:ext cx="680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arget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A8B9A48F-DF98-7145-93B5-99D1FF366294}"/>
              </a:ext>
            </a:extLst>
          </p:cNvPr>
          <p:cNvCxnSpPr>
            <a:cxnSpLocks/>
          </p:cNvCxnSpPr>
          <p:nvPr/>
        </p:nvCxnSpPr>
        <p:spPr>
          <a:xfrm>
            <a:off x="1680519" y="2296065"/>
            <a:ext cx="86963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1E7840F-566B-E142-ACF0-8221D378AC22}"/>
              </a:ext>
            </a:extLst>
          </p:cNvPr>
          <p:cNvSpPr txBox="1"/>
          <p:nvPr/>
        </p:nvSpPr>
        <p:spPr>
          <a:xfrm>
            <a:off x="4031341" y="1901087"/>
            <a:ext cx="1346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orward (5’-3’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329F74E-5DFD-9B40-87D5-DEFABF08FF40}"/>
              </a:ext>
            </a:extLst>
          </p:cNvPr>
          <p:cNvSpPr txBox="1"/>
          <p:nvPr/>
        </p:nvSpPr>
        <p:spPr>
          <a:xfrm>
            <a:off x="8176387" y="1901087"/>
            <a:ext cx="1358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verse (5’-3’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6299A66-1A7F-4D4D-898E-1800BC77EC4B}"/>
              </a:ext>
            </a:extLst>
          </p:cNvPr>
          <p:cNvSpPr txBox="1"/>
          <p:nvPr/>
        </p:nvSpPr>
        <p:spPr>
          <a:xfrm>
            <a:off x="1663243" y="2308421"/>
            <a:ext cx="1162498" cy="33239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yomaker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yomerger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am12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1D-integrin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1-integrin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-cadherin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-cadherin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veolin-3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yoferin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MyHC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x7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yogenin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6E0B6DC-EEDA-854B-8326-521AC0711C56}"/>
              </a:ext>
            </a:extLst>
          </p:cNvPr>
          <p:cNvSpPr txBox="1"/>
          <p:nvPr/>
        </p:nvSpPr>
        <p:spPr>
          <a:xfrm>
            <a:off x="3011575" y="2308421"/>
            <a:ext cx="3386376" cy="33855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CCGTAAAGACCTCTATGCCAAC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TGTCCGTCGTGGATCTG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CCACTCATTTCAGAGCCTAGAAG</a:t>
            </a:r>
            <a:r>
              <a:rPr lang="ja-JP" altLang="ja-JP" sz="1400">
                <a:effectLst/>
              </a:rPr>
              <a:t> 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CGCTACCAAGAGGCGTT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GGAGGGCAAGAAGTTCA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GGCAAGAAGGCATAAGAGAGAG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CCCAATTGTAGCAGGC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CCCAATTGTAGCAGGC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GGCAGTCCCTGAGCCCAA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GCAGATTTCAAGGTGGACG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ACCCCAAGAACATCAATGAGGAC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TACCAGAATGAGAATCGCTACCC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AAGCTGTTCTTGTGGATGGTC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GCCTTGTTTGGGCAGCTT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GTGAATGCAACTCCCACAG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27C2FB2-2CFF-9048-9CB6-CEED62B7665D}"/>
              </a:ext>
            </a:extLst>
          </p:cNvPr>
          <p:cNvSpPr txBox="1"/>
          <p:nvPr/>
        </p:nvSpPr>
        <p:spPr>
          <a:xfrm>
            <a:off x="7238342" y="2308421"/>
            <a:ext cx="3234155" cy="33239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GGAGCCACCGATCCAC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TGCTGTTGAAGTCGCAGGA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GGCATGGTTATCTGGCTC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CAGCACAGACAAACCAG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GTCTTGGGAGCTCAGTC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GTGAATGGGTCCTGGCTTAT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AGACCAGCTTTACGTCCATA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GTGTCCCACTTGGCATTCAT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CCAGCGTGGCATTGAGGTAC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CCTGGGTTTCTTTGTCTTGGG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GAAGGAGATACAGGCGAACAGG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TACCAGAATGAGAATCGCTACCC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CAGCTGCTCCAGGCTGTTA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CAGTCTGGCCACTGGAAATC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GACGTAAGGGAGTGCAGA</a:t>
            </a: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1225E8F9-537D-5649-8D4C-8D7883CD43BA}"/>
              </a:ext>
            </a:extLst>
          </p:cNvPr>
          <p:cNvCxnSpPr>
            <a:cxnSpLocks/>
          </p:cNvCxnSpPr>
          <p:nvPr/>
        </p:nvCxnSpPr>
        <p:spPr>
          <a:xfrm>
            <a:off x="1690044" y="5573495"/>
            <a:ext cx="8686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7783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6">
            <a:extLst>
              <a:ext uri="{FF2B5EF4-FFF2-40B4-BE49-F238E27FC236}">
                <a16:creationId xmlns:a16="http://schemas.microsoft.com/office/drawing/2014/main" id="{1C38366B-1245-4909-9037-023881A7480C}"/>
              </a:ext>
            </a:extLst>
          </p:cNvPr>
          <p:cNvSpPr txBox="1"/>
          <p:nvPr/>
        </p:nvSpPr>
        <p:spPr>
          <a:xfrm>
            <a:off x="3408981" y="174277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34">
            <a:extLst>
              <a:ext uri="{FF2B5EF4-FFF2-40B4-BE49-F238E27FC236}">
                <a16:creationId xmlns:a16="http://schemas.microsoft.com/office/drawing/2014/main" id="{2F941187-BF2B-4927-934F-F00392232355}"/>
              </a:ext>
            </a:extLst>
          </p:cNvPr>
          <p:cNvSpPr txBox="1"/>
          <p:nvPr/>
        </p:nvSpPr>
        <p:spPr>
          <a:xfrm>
            <a:off x="6148758" y="174277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874C7125-3379-4326-BA23-86A599CE84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1901" y="2084561"/>
            <a:ext cx="1787500" cy="405762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180AB41-4BD5-4479-94F7-66DF17DC90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9754" y="2092642"/>
            <a:ext cx="1787500" cy="3968250"/>
          </a:xfrm>
          <a:prstGeom prst="rect">
            <a:avLst/>
          </a:prstGeom>
        </p:spPr>
      </p:pic>
      <p:sp>
        <p:nvSpPr>
          <p:cNvPr id="6" name="テキスト ボックス 25">
            <a:extLst>
              <a:ext uri="{FF2B5EF4-FFF2-40B4-BE49-F238E27FC236}">
                <a16:creationId xmlns:a16="http://schemas.microsoft.com/office/drawing/2014/main" id="{15163550-6BAF-40A8-972E-1E2E7226A4D3}"/>
              </a:ext>
            </a:extLst>
          </p:cNvPr>
          <p:cNvSpPr txBox="1"/>
          <p:nvPr/>
        </p:nvSpPr>
        <p:spPr>
          <a:xfrm>
            <a:off x="10708902" y="-1151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0525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59604ED-B045-A742-845E-318A481A3185}"/>
              </a:ext>
            </a:extLst>
          </p:cNvPr>
          <p:cNvSpPr txBox="1"/>
          <p:nvPr/>
        </p:nvSpPr>
        <p:spPr>
          <a:xfrm>
            <a:off x="3385539" y="2585196"/>
            <a:ext cx="4695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95B5234-0970-234A-A250-561E8496F7EB}"/>
              </a:ext>
            </a:extLst>
          </p:cNvPr>
          <p:cNvSpPr txBox="1"/>
          <p:nvPr/>
        </p:nvSpPr>
        <p:spPr>
          <a:xfrm>
            <a:off x="3416026" y="383985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BC9AD0A-8AB5-054E-9A28-71530828573A}"/>
              </a:ext>
            </a:extLst>
          </p:cNvPr>
          <p:cNvSpPr txBox="1"/>
          <p:nvPr/>
        </p:nvSpPr>
        <p:spPr>
          <a:xfrm>
            <a:off x="4860194" y="445499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-Ctrl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63F26D0-BC6B-3D4F-81C0-729E5A4C0910}"/>
              </a:ext>
            </a:extLst>
          </p:cNvPr>
          <p:cNvSpPr txBox="1"/>
          <p:nvPr/>
        </p:nvSpPr>
        <p:spPr>
          <a:xfrm>
            <a:off x="6116744" y="445499"/>
            <a:ext cx="994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-STAT6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E3ECE156-AF04-F748-B80F-318A75CC6D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8816" y="2852738"/>
            <a:ext cx="1460500" cy="2882900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11C1D15-D04D-DD4D-ACE9-35043ECF9D2C}"/>
              </a:ext>
            </a:extLst>
          </p:cNvPr>
          <p:cNvSpPr txBox="1"/>
          <p:nvPr/>
        </p:nvSpPr>
        <p:spPr>
          <a:xfrm>
            <a:off x="7017885" y="2584396"/>
            <a:ext cx="4695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570D7B7-F0FF-9849-8020-6487714F3A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53953" y="741244"/>
            <a:ext cx="2819400" cy="1397000"/>
          </a:xfrm>
          <a:prstGeom prst="rect">
            <a:avLst/>
          </a:prstGeom>
        </p:spPr>
      </p:pic>
      <p:sp>
        <p:nvSpPr>
          <p:cNvPr id="11" name="テキスト ボックス 25">
            <a:extLst>
              <a:ext uri="{FF2B5EF4-FFF2-40B4-BE49-F238E27FC236}">
                <a16:creationId xmlns:a16="http://schemas.microsoft.com/office/drawing/2014/main" id="{841E9AFA-0C2A-4BF8-965F-2244A72E3E9F}"/>
              </a:ext>
            </a:extLst>
          </p:cNvPr>
          <p:cNvSpPr txBox="1"/>
          <p:nvPr/>
        </p:nvSpPr>
        <p:spPr>
          <a:xfrm>
            <a:off x="10708902" y="-1151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1D6BF302-D3AF-F340-9186-5F0E0C1D3C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6073" y="2852738"/>
            <a:ext cx="3009900" cy="236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764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DCF9B17-6495-6344-B702-6148277AAC9E}"/>
              </a:ext>
            </a:extLst>
          </p:cNvPr>
          <p:cNvSpPr txBox="1"/>
          <p:nvPr/>
        </p:nvSpPr>
        <p:spPr>
          <a:xfrm>
            <a:off x="3437641" y="194612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5F44980-A963-164B-A3A7-F92836FC7166}"/>
              </a:ext>
            </a:extLst>
          </p:cNvPr>
          <p:cNvSpPr txBox="1"/>
          <p:nvPr/>
        </p:nvSpPr>
        <p:spPr>
          <a:xfrm>
            <a:off x="5121007" y="1946124"/>
            <a:ext cx="1025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TAT6 KO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B4B0706-A554-B343-AD54-47F06E1DDA53}"/>
              </a:ext>
            </a:extLst>
          </p:cNvPr>
          <p:cNvSpPr txBox="1"/>
          <p:nvPr/>
        </p:nvSpPr>
        <p:spPr>
          <a:xfrm>
            <a:off x="4985788" y="4167629"/>
            <a:ext cx="1739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x7</a:t>
            </a:r>
            <a:r>
              <a:rPr lang="en-US" altLang="ja-JP" sz="14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aminin </a:t>
            </a:r>
            <a:r>
              <a:rPr lang="en-US" altLang="ja-JP" sz="1400" dirty="0">
                <a:solidFill>
                  <a:srgbClr val="0028F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ja-JP" altLang="en-US" sz="1400" dirty="0">
              <a:solidFill>
                <a:schemeClr val="accent2">
                  <a:lumMod val="60000"/>
                  <a:lumOff val="4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D7133FD-41D9-984D-A605-19B491192B4F}"/>
              </a:ext>
            </a:extLst>
          </p:cNvPr>
          <p:cNvSpPr txBox="1"/>
          <p:nvPr/>
        </p:nvSpPr>
        <p:spPr>
          <a:xfrm>
            <a:off x="1968668" y="148378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4CE8E60-1C0A-194A-B4BF-2083B088A7C1}"/>
              </a:ext>
            </a:extLst>
          </p:cNvPr>
          <p:cNvSpPr txBox="1"/>
          <p:nvPr/>
        </p:nvSpPr>
        <p:spPr>
          <a:xfrm>
            <a:off x="7656197" y="148378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6B63060F-DD72-BB47-AEB5-0D966C01D5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8067" y="2219883"/>
            <a:ext cx="1981200" cy="19812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1942F91E-76DC-8B49-9A34-84AB8C76F7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38001" y="2219883"/>
            <a:ext cx="1981200" cy="1981200"/>
          </a:xfrm>
          <a:prstGeom prst="rect">
            <a:avLst/>
          </a:prstGeom>
        </p:spPr>
      </p:pic>
      <p:sp>
        <p:nvSpPr>
          <p:cNvPr id="19" name="テキスト ボックス 25">
            <a:extLst>
              <a:ext uri="{FF2B5EF4-FFF2-40B4-BE49-F238E27FC236}">
                <a16:creationId xmlns:a16="http://schemas.microsoft.com/office/drawing/2014/main" id="{AEC31241-E18A-4C82-BFED-ED8D8E1D24FE}"/>
              </a:ext>
            </a:extLst>
          </p:cNvPr>
          <p:cNvSpPr txBox="1"/>
          <p:nvPr/>
        </p:nvSpPr>
        <p:spPr>
          <a:xfrm>
            <a:off x="10708902" y="-1151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69499FF3-6E4E-8A44-967D-A767664E9C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05402" y="1822338"/>
            <a:ext cx="1346200" cy="2895600"/>
          </a:xfrm>
          <a:prstGeom prst="rect">
            <a:avLst/>
          </a:prstGeom>
        </p:spPr>
      </p:pic>
      <p:sp>
        <p:nvSpPr>
          <p:cNvPr id="12" name="テキスト ボックス 59">
            <a:extLst>
              <a:ext uri="{FF2B5EF4-FFF2-40B4-BE49-F238E27FC236}">
                <a16:creationId xmlns:a16="http://schemas.microsoft.com/office/drawing/2014/main" id="{AE2E4605-96C1-4E6D-98B4-233655372B84}"/>
              </a:ext>
            </a:extLst>
          </p:cNvPr>
          <p:cNvSpPr txBox="1"/>
          <p:nvPr/>
        </p:nvSpPr>
        <p:spPr>
          <a:xfrm>
            <a:off x="4109275" y="1620863"/>
            <a:ext cx="993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njured T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24">
            <a:extLst>
              <a:ext uri="{FF2B5EF4-FFF2-40B4-BE49-F238E27FC236}">
                <a16:creationId xmlns:a16="http://schemas.microsoft.com/office/drawing/2014/main" id="{CBF0AA5F-74EB-4CB0-9904-28087ED6293A}"/>
              </a:ext>
            </a:extLst>
          </p:cNvPr>
          <p:cNvCxnSpPr>
            <a:cxnSpLocks/>
          </p:cNvCxnSpPr>
          <p:nvPr/>
        </p:nvCxnSpPr>
        <p:spPr>
          <a:xfrm>
            <a:off x="2931075" y="1925786"/>
            <a:ext cx="32918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61232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Widescreen</PresentationFormat>
  <Paragraphs>6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GURA Y</dc:creator>
  <cp:lastModifiedBy>OGURA Y</cp:lastModifiedBy>
  <cp:revision>1</cp:revision>
  <dcterms:created xsi:type="dcterms:W3CDTF">2021-03-31T05:52:37Z</dcterms:created>
  <dcterms:modified xsi:type="dcterms:W3CDTF">2021-03-31T05:53:05Z</dcterms:modified>
</cp:coreProperties>
</file>